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80890" autoAdjust="0"/>
  </p:normalViewPr>
  <p:slideViewPr>
    <p:cSldViewPr snapToGrid="0" showGuides="1">
      <p:cViewPr varScale="1">
        <p:scale>
          <a:sx n="66" d="100"/>
          <a:sy n="66" d="100"/>
        </p:scale>
        <p:origin x="1301" y="6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FA556A2-71F9-4834-B903-2367797405AB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1EBDB4-3341-4571-AB20-8F37F1DE334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580493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zh-CN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l Digital Content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Figure 1. CXHO active compounds and 17 core targets network; The circular nodes at the edges represent the compound, and the circular nodes in the center represent the core targets.</a:t>
            </a:r>
            <a:r>
              <a:rPr lang="en-US" altLang="zh-CN" sz="1200" kern="100" dirty="0">
                <a:solidFill>
                  <a:srgbClr val="101214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2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he larger the circle, the stronger the target interacts with other targets or drugs. </a:t>
            </a:r>
            <a:endParaRPr lang="zh-CN" altLang="zh-CN" sz="12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51EBDB4-3341-4571-AB20-8F37F1DE334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90651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C0664F4-618E-B4B2-1492-1CEBB186DF8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F95B22B-9EFC-6A67-02FB-A0C0DC874BC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8F04653-2003-1FE9-CA50-229A47CE0E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31C64B4F-B1ED-983D-0776-8AA2D7C08A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A8512CDC-3293-608B-261F-387CA59F95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977052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AB4CA1-0A10-DDFC-AED4-10F2B5AABB7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EF82D02-9FDF-DC20-0D57-29C8B545A78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7D443FB-B209-FE62-B8DA-9B73F6774F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FFB2D6A9-FA90-8282-9D4A-707B4B8D7D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E6836B6-32C8-2D4F-FA5C-B1FD74CD62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98480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DEF6AAE-6332-D7C6-F852-8C98B20679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71B0584-9272-F8F2-4DA8-73897A2724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FBF44D1-9E8E-333F-C02A-770CF93D8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F415DA9-9D3C-855E-2976-8FB8908164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B5F204D-9EB2-364D-4F58-300BDD9F6A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16559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FEF3343-5530-E161-E5D7-8F785B093B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7632014-C85A-AD96-0498-621F1006B49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E140DB5-A506-B2FE-550C-5F1422717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12AAD40-9D08-3569-EABD-407D4725C3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B551391-A181-90CF-AF21-21B8B0A151E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12532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08E19E-9ACD-70EB-0669-D10BBA3C8A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DBE74FB-6C58-7882-9A21-8521DB63D4E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000440A-1723-20B4-D2FF-BAE18A41D1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CD52E28-1910-79D5-0B13-B66C404B8A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8FEF3A6-8BE3-A3A4-552A-DDA6418D6C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148449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A3E446-2D7B-9E1B-EC97-297F13293E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C22D650-403A-5D2D-D135-313595BB5E7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BF84007-BD7B-273A-5EF8-0432C9536F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DB0F2EE-DF24-44C6-A649-158C27FD9D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B8C4847-7D93-A692-E9E1-26A722AC16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1B353A9-1DD9-60C9-1110-532C712E624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691503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9F6754-5C00-F694-AFAE-F2D6E17D59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C2FD0A8-D55F-0633-64A2-8796B17AB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6794BF8-B4B4-FCA6-C070-D532F135DD3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E8DBCCCC-6E20-4EC7-F994-269246C615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8875DAF-7EA8-BCEC-31D7-1C6C358F181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FFB01BB4-4852-3E87-ED06-DB69374950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D78EDCF-256A-1C71-105E-7754133B7D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F175188-9BD6-FA25-5B62-07BE0CABA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043649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0558D8D-7E0C-14B7-8380-F490B42BAA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B730CBC-C056-4D8B-0512-22A621DB57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6D7BBAE-6B85-9903-83C2-8ED6CB334D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B8A15B51-FDE7-249E-7318-660798E647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147365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6199ED4B-93F8-B420-6117-63120C18B9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9AEA10AC-F993-B029-7CB0-3895BBF6B4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2EA762AE-9FDA-4E21-896A-1F4699775C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857567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9AB13A-E881-C900-1C7A-000A69A6AA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01C5CC98-C4CE-137A-6EEF-39826831B6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13C3B90-6386-6FCF-4B50-63A26CAC43F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7859D198-8940-DD5B-21D0-13BF38822F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6E82BEF4-5C07-437A-D295-BD4A5DA854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353246F-BD6A-23EB-7544-7CB1691F88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169573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40D9CF8-DB0E-C7B6-8BDE-6191BCC4FD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00EC49D-51BA-84BE-3A4F-607C014E982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34C3EC1-594F-C891-ECB0-F2753314A9E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81A73F2-72D3-ED8A-BF27-364C58AE3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22ED2DA-848D-047D-7CF5-1D981478CC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A8274CD-E69D-FEC5-6780-28933DDCD7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66829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21863FA-9E0F-F175-A47C-A7F017CDA3A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96156EB1-4A87-326A-8068-6BB5EAD25F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07C7280-9126-36C7-9B2A-0C95B6ACC0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902B3E-AFDC-479F-8B29-195FFFB45896}" type="datetimeFigureOut">
              <a:rPr lang="zh-CN" altLang="en-US" smtClean="0"/>
              <a:t>2023-07-0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D02FEB7-C682-463B-CB31-AB8AFCD1315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5313FDE-F95C-45D8-1F1F-995F400206E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EB598-0436-4DC5-9270-37F5253866C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70548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33399C6D-AA6F-1C61-2F3B-24C4881AA2C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14956" y="502920"/>
            <a:ext cx="7562088" cy="5852160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5523F923-F8CC-4219-E50A-C9254C8766C2}"/>
              </a:ext>
            </a:extLst>
          </p:cNvPr>
          <p:cNvSpPr txBox="1"/>
          <p:nvPr/>
        </p:nvSpPr>
        <p:spPr>
          <a:xfrm>
            <a:off x="0" y="5471938"/>
            <a:ext cx="12192000" cy="128625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8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Supplemental Digital Content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Figure 1. CXHO active compounds and 17 core targets network; The circular nodes at the edges represent the compound, and the circular nodes in the center represent the core targets.</a:t>
            </a:r>
            <a:r>
              <a:rPr lang="en-US" altLang="zh-CN" sz="1800" kern="100" dirty="0">
                <a:solidFill>
                  <a:srgbClr val="101214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 </a:t>
            </a:r>
            <a:r>
              <a:rPr lang="en-US" altLang="zh-CN" sz="1800" dirty="0"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宋体" panose="02010600030101010101" pitchFamily="2" charset="-122"/>
              </a:rPr>
              <a:t>The larger the circle, the stronger the target interacts with other targets or drugs. </a:t>
            </a:r>
            <a:endParaRPr lang="zh-CN" altLang="zh-CN" sz="2000" dirty="0">
              <a:effectLst/>
              <a:latin typeface="宋体" panose="02010600030101010101" pitchFamily="2" charset="-122"/>
              <a:ea typeface="宋体" panose="02010600030101010101" pitchFamily="2" charset="-122"/>
              <a:cs typeface="宋体" panose="02010600030101010101" pitchFamily="2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16749593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07</Words>
  <Application>Microsoft Office PowerPoint</Application>
  <PresentationFormat>宽屏</PresentationFormat>
  <Paragraphs>3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宋体</vt:lpstr>
      <vt:lpstr>Arial</vt:lpstr>
      <vt:lpstr>Times New Roman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budourousuli kayisaier</dc:creator>
  <cp:lastModifiedBy>abudourousuli kayisaier</cp:lastModifiedBy>
  <cp:revision>1</cp:revision>
  <dcterms:created xsi:type="dcterms:W3CDTF">2023-07-04T09:35:20Z</dcterms:created>
  <dcterms:modified xsi:type="dcterms:W3CDTF">2023-07-04T09:36:26Z</dcterms:modified>
</cp:coreProperties>
</file>